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1" r:id="rId2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36" autoAdjust="0"/>
    <p:restoredTop sz="67551"/>
  </p:normalViewPr>
  <p:slideViewPr>
    <p:cSldViewPr snapToGrid="0" snapToObjects="1">
      <p:cViewPr>
        <p:scale>
          <a:sx n="25" d="100"/>
          <a:sy n="25" d="100"/>
        </p:scale>
        <p:origin x="-3996" y="-492"/>
      </p:cViewPr>
      <p:guideLst>
        <p:guide orient="horz" pos="5120"/>
        <p:guide pos="3840"/>
      </p:guideLst>
    </p:cSldViewPr>
  </p:slideViewPr>
  <p:notesTextViewPr>
    <p:cViewPr>
      <p:scale>
        <a:sx n="50" d="100"/>
        <a:sy n="50" d="100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BF6239-C732-FB47-9ED2-CA4902B7BC63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A5FB36-6B9E-F042-84C0-D74D0153ABC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3036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Pharmacokinetics effects of durvalumab on olaparib and cediranib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-B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urvalumab did not affect olaparib PK Cmax or AUC</a:t>
            </a:r>
          </a:p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-D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presence of durvalumab did not significantly affect cediranib PK. One patient’s PK data is missing due to no sample collection.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AUC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area under the plasma concentration v. time curve from time zero to infinity. AUC/D: Area under the plasma concentration v. time curve normalized to dose. AUC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U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AUC for the dosing interval for steady-state kinetics after durvalumab; 12hr for olaparib, 24hr for cediranib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 dot: one patient with abnormally low plasma concentrations that led to higher than normal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s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F.  Reason is unclear, potentially food effect issue with absorption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A5FB36-6B9E-F042-84C0-D74D0153ABC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9728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0724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1498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3033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3679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389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4845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5053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451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4219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7747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0982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6E239-B447-2042-B044-52F2CE4F9FFB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D7EE2-FC4C-E445-A307-7334EE6CAD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308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xmlns="" id="{0B75F4FF-8062-4044-919A-922C5AB57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86818" y="10073866"/>
            <a:ext cx="259214" cy="4703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1" rIns="91440" bIns="45721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801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A2E0C0AD-B968-C541-BD7D-CC18235461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402889"/>
              </p:ext>
            </p:extLst>
          </p:nvPr>
        </p:nvGraphicFramePr>
        <p:xfrm>
          <a:off x="970727" y="5101276"/>
          <a:ext cx="4735796" cy="28995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" r:id="rId4" imgW="3860800" imgH="2616200" progId="Prism7.Document">
                  <p:embed/>
                </p:oleObj>
              </mc:Choice>
              <mc:Fallback>
                <p:oleObj r:id="rId4" imgW="3860800" imgH="2616200" progId="Prism7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70727" y="5101276"/>
                        <a:ext cx="4735796" cy="289951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4">
            <a:extLst>
              <a:ext uri="{FF2B5EF4-FFF2-40B4-BE49-F238E27FC236}">
                <a16:creationId xmlns:a16="http://schemas.microsoft.com/office/drawing/2014/main" xmlns="" id="{3D91B45B-5284-AA49-BBA6-60B27028DF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8604" y="10073866"/>
            <a:ext cx="259214" cy="4703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1" rIns="91440" bIns="45721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801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78871F6E-C42D-C044-B868-1CCABEDF5019}"/>
              </a:ext>
            </a:extLst>
          </p:cNvPr>
          <p:cNvSpPr/>
          <p:nvPr/>
        </p:nvSpPr>
        <p:spPr>
          <a:xfrm rot="16200000">
            <a:off x="28715" y="6344950"/>
            <a:ext cx="2587185" cy="4455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diranib (ng/mL/mg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9252099A-B55A-0B41-863B-2DCD18D7AC62}"/>
              </a:ext>
            </a:extLst>
          </p:cNvPr>
          <p:cNvSpPr/>
          <p:nvPr/>
        </p:nvSpPr>
        <p:spPr>
          <a:xfrm>
            <a:off x="1803742" y="7647506"/>
            <a:ext cx="1568212" cy="3036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cs typeface="Arial" panose="020B0604020202020204" pitchFamily="34" charset="0"/>
              </a:rPr>
              <a:t>First Dose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0181B47C-226D-9E49-BFDC-03B83787CAC0}"/>
              </a:ext>
            </a:extLst>
          </p:cNvPr>
          <p:cNvSpPr/>
          <p:nvPr/>
        </p:nvSpPr>
        <p:spPr>
          <a:xfrm>
            <a:off x="3601029" y="7636588"/>
            <a:ext cx="1407827" cy="3176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cs typeface="Arial" panose="020B0604020202020204" pitchFamily="34" charset="0"/>
              </a:rPr>
              <a:t>Steady-State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4712C0AA-4A54-5341-A437-671B28CB6809}"/>
              </a:ext>
            </a:extLst>
          </p:cNvPr>
          <p:cNvSpPr/>
          <p:nvPr/>
        </p:nvSpPr>
        <p:spPr>
          <a:xfrm>
            <a:off x="2638716" y="5291600"/>
            <a:ext cx="2418595" cy="4849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value (paired): 0.140</a:t>
            </a:r>
          </a:p>
          <a:p>
            <a:endParaRPr 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xmlns="" id="{63EA1010-DDAC-4D4B-8C7C-6E17B79036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0341037"/>
              </p:ext>
            </p:extLst>
          </p:nvPr>
        </p:nvGraphicFramePr>
        <p:xfrm>
          <a:off x="6063391" y="5087880"/>
          <a:ext cx="4652748" cy="28641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" r:id="rId6" imgW="3937000" imgH="2667000" progId="Prism7.Document">
                  <p:embed/>
                </p:oleObj>
              </mc:Choice>
              <mc:Fallback>
                <p:oleObj r:id="rId6" imgW="3937000" imgH="2667000" progId="Prism7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063391" y="5087880"/>
                        <a:ext cx="4652748" cy="286417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35F5C8D2-F8D5-1149-893D-C0ABA7D27DAF}"/>
              </a:ext>
            </a:extLst>
          </p:cNvPr>
          <p:cNvSpPr/>
          <p:nvPr/>
        </p:nvSpPr>
        <p:spPr>
          <a:xfrm rot="16200000">
            <a:off x="5032223" y="6418103"/>
            <a:ext cx="2764477" cy="4276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diranib (hr*ng/mL/mg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D4ADB1C1-FCB7-6341-BBD0-7D059B676D47}"/>
              </a:ext>
            </a:extLst>
          </p:cNvPr>
          <p:cNvSpPr/>
          <p:nvPr/>
        </p:nvSpPr>
        <p:spPr>
          <a:xfrm>
            <a:off x="7135106" y="7626402"/>
            <a:ext cx="1443470" cy="3256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cs typeface="Arial" panose="020B0604020202020204" pitchFamily="34" charset="0"/>
              </a:rPr>
              <a:t>AUCinf/D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8A18E81D-912A-6843-8247-59EAA1CEE8ED}"/>
              </a:ext>
            </a:extLst>
          </p:cNvPr>
          <p:cNvSpPr/>
          <p:nvPr/>
        </p:nvSpPr>
        <p:spPr>
          <a:xfrm>
            <a:off x="8755555" y="7644894"/>
            <a:ext cx="1247443" cy="3071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cs typeface="Arial" panose="020B0604020202020204" pitchFamily="34" charset="0"/>
              </a:rPr>
              <a:t>AUCtau/D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1F39F7F7-E954-914F-8DA1-9CA2281F22AE}"/>
              </a:ext>
            </a:extLst>
          </p:cNvPr>
          <p:cNvSpPr/>
          <p:nvPr/>
        </p:nvSpPr>
        <p:spPr>
          <a:xfrm>
            <a:off x="7721961" y="5249711"/>
            <a:ext cx="2597750" cy="4203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value (paired): 0.039</a:t>
            </a:r>
          </a:p>
          <a:p>
            <a:endParaRPr 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B9AB36F-C1DB-404E-9011-E078CA2F97E0}"/>
              </a:ext>
            </a:extLst>
          </p:cNvPr>
          <p:cNvSpPr txBox="1"/>
          <p:nvPr/>
        </p:nvSpPr>
        <p:spPr>
          <a:xfrm>
            <a:off x="840700" y="160795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E1577449-ECD5-FF44-925C-83CF765C5B68}"/>
              </a:ext>
            </a:extLst>
          </p:cNvPr>
          <p:cNvSpPr txBox="1"/>
          <p:nvPr/>
        </p:nvSpPr>
        <p:spPr>
          <a:xfrm>
            <a:off x="5961076" y="1607116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26E7CEDE-699F-E34E-B7E8-8E0D43B1AD51}"/>
              </a:ext>
            </a:extLst>
          </p:cNvPr>
          <p:cNvSpPr txBox="1"/>
          <p:nvPr/>
        </p:nvSpPr>
        <p:spPr>
          <a:xfrm>
            <a:off x="840700" y="487044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CA375C67-5C89-5B4A-8DFD-1D1DEE18C146}"/>
              </a:ext>
            </a:extLst>
          </p:cNvPr>
          <p:cNvSpPr txBox="1"/>
          <p:nvPr/>
        </p:nvSpPr>
        <p:spPr>
          <a:xfrm>
            <a:off x="5940236" y="487044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C7C29971-A429-484A-A282-3F40B39355CA}"/>
              </a:ext>
            </a:extLst>
          </p:cNvPr>
          <p:cNvSpPr txBox="1"/>
          <p:nvPr/>
        </p:nvSpPr>
        <p:spPr>
          <a:xfrm>
            <a:off x="9317320" y="337534"/>
            <a:ext cx="2459841" cy="6465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801" b="1" dirty="0"/>
              <a:t>Supplementary Figure 1</a:t>
            </a:r>
          </a:p>
          <a:p>
            <a:pPr algn="r"/>
            <a:r>
              <a:rPr lang="en-US" sz="1801" b="1" dirty="0"/>
              <a:t>Zimmer et al.</a:t>
            </a:r>
            <a:endParaRPr lang="en-US" sz="1801" dirty="0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D5C047AC-D7B2-FC45-B27B-879C9346D056}"/>
              </a:ext>
            </a:extLst>
          </p:cNvPr>
          <p:cNvGrpSpPr/>
          <p:nvPr/>
        </p:nvGrpSpPr>
        <p:grpSpPr>
          <a:xfrm>
            <a:off x="1137782" y="1950006"/>
            <a:ext cx="4401687" cy="2635146"/>
            <a:chOff x="1137782" y="1950006"/>
            <a:chExt cx="4401687" cy="263514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48357B05-F8C8-6F4C-B7DE-C8BA4FD14646}"/>
                </a:ext>
              </a:extLst>
            </p:cNvPr>
            <p:cNvPicPr/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7782" y="1950006"/>
              <a:ext cx="4401687" cy="263514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876380E8-53A0-4140-86A5-4D0C79EC14EB}"/>
                </a:ext>
              </a:extLst>
            </p:cNvPr>
            <p:cNvSpPr/>
            <p:nvPr/>
          </p:nvSpPr>
          <p:spPr>
            <a:xfrm>
              <a:off x="2638716" y="2181727"/>
              <a:ext cx="2061621" cy="2887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             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E8AB34B0-0D22-C740-AA57-C7AC1237C400}"/>
              </a:ext>
            </a:extLst>
          </p:cNvPr>
          <p:cNvGrpSpPr/>
          <p:nvPr/>
        </p:nvGrpSpPr>
        <p:grpSpPr>
          <a:xfrm>
            <a:off x="6255559" y="2038922"/>
            <a:ext cx="4401687" cy="2457314"/>
            <a:chOff x="6255559" y="2038922"/>
            <a:chExt cx="4401687" cy="245731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8B808FBC-D064-2B4C-B1CD-F12108AF7561}"/>
                </a:ext>
              </a:extLst>
            </p:cNvPr>
            <p:cNvPicPr/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55559" y="2038922"/>
              <a:ext cx="4401687" cy="245731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95D19BA2-AB40-5147-A59D-9B40A7B010FF}"/>
                </a:ext>
              </a:extLst>
            </p:cNvPr>
            <p:cNvSpPr/>
            <p:nvPr/>
          </p:nvSpPr>
          <p:spPr>
            <a:xfrm>
              <a:off x="7819946" y="2294023"/>
              <a:ext cx="1871218" cy="1764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019795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8</TotalTime>
  <Words>171</Words>
  <Application>Microsoft Office PowerPoint</Application>
  <PresentationFormat>Custom</PresentationFormat>
  <Paragraphs>21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7.Documen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immer, Alexandra (NIH/NCI) [E]</dc:creator>
  <cp:lastModifiedBy>JADIQUE</cp:lastModifiedBy>
  <cp:revision>75</cp:revision>
  <dcterms:created xsi:type="dcterms:W3CDTF">2018-11-01T18:24:33Z</dcterms:created>
  <dcterms:modified xsi:type="dcterms:W3CDTF">2019-07-16T17:46:55Z</dcterms:modified>
</cp:coreProperties>
</file>